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290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9" autoAdjust="0"/>
    <p:restoredTop sz="94383" autoAdjust="0"/>
  </p:normalViewPr>
  <p:slideViewPr>
    <p:cSldViewPr snapToGrid="0">
      <p:cViewPr varScale="1">
        <p:scale>
          <a:sx n="83" d="100"/>
          <a:sy n="83" d="100"/>
        </p:scale>
        <p:origin x="29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C11A0-1BC4-4E64-804B-2FF606FD05A1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33AF0C-7E16-466F-9102-E936CCF9A30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9332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5173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1680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7141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24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6101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648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9626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8458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8507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6895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2255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C53AB-AB58-409B-8DB6-74A265C385CC}" type="datetimeFigureOut">
              <a:rPr lang="es-ES" smtClean="0"/>
              <a:t>02/07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D046B-28B6-4180-96E8-EE6E6334214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492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/>
          <a:srcRect l="2903" b="2903"/>
          <a:stretch/>
        </p:blipFill>
        <p:spPr>
          <a:xfrm>
            <a:off x="1011224" y="1134664"/>
            <a:ext cx="4359110" cy="435911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112471" y="131962"/>
            <a:ext cx="65321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dirty="0" smtClean="0"/>
              <a:t>Figure S1. </a:t>
            </a:r>
            <a:r>
              <a:rPr lang="en-US" sz="1200" dirty="0" smtClean="0"/>
              <a:t>Linkage </a:t>
            </a:r>
            <a:r>
              <a:rPr lang="en-US" sz="1200" dirty="0"/>
              <a:t>disequilibrium (</a:t>
            </a:r>
            <a:r>
              <a:rPr lang="en-US" sz="1200" i="1" dirty="0"/>
              <a:t>r</a:t>
            </a:r>
            <a:r>
              <a:rPr lang="en-US" sz="1200" baseline="30000" dirty="0"/>
              <a:t>2</a:t>
            </a:r>
            <a:r>
              <a:rPr lang="en-US" sz="1200" dirty="0"/>
              <a:t>) decay over physical distance (</a:t>
            </a:r>
            <a:r>
              <a:rPr lang="en-US" sz="1200" dirty="0" err="1"/>
              <a:t>bp</a:t>
            </a:r>
            <a:r>
              <a:rPr lang="en-US" sz="1200" dirty="0"/>
              <a:t>) in the 882 barley accessions. The black dots indicate the </a:t>
            </a:r>
            <a:r>
              <a:rPr lang="en-US" sz="1200" i="1" dirty="0"/>
              <a:t>r</a:t>
            </a:r>
            <a:r>
              <a:rPr lang="en-US" sz="1200" baseline="30000" dirty="0"/>
              <a:t>2</a:t>
            </a:r>
            <a:r>
              <a:rPr lang="en-US" sz="1200" dirty="0"/>
              <a:t>  values of all SNP pairs within chromosomes. The green horizontal line indicates the 99</a:t>
            </a:r>
            <a:r>
              <a:rPr lang="en-US" sz="1200" baseline="30000" dirty="0"/>
              <a:t>th</a:t>
            </a:r>
            <a:r>
              <a:rPr lang="en-US" sz="1200" dirty="0"/>
              <a:t> percentile of the distribution of </a:t>
            </a:r>
            <a:r>
              <a:rPr lang="en-US" sz="1200" i="1" dirty="0"/>
              <a:t>r</a:t>
            </a:r>
            <a:r>
              <a:rPr lang="en-US" sz="1200" baseline="30000" dirty="0"/>
              <a:t>2</a:t>
            </a:r>
            <a:r>
              <a:rPr lang="en-US" sz="1200" dirty="0" smtClean="0"/>
              <a:t> </a:t>
            </a:r>
            <a:r>
              <a:rPr lang="en-US" sz="1200" dirty="0"/>
              <a:t>values for unlinked markers.</a:t>
            </a:r>
            <a:endParaRPr lang="es-ES" sz="12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749614" y="3104662"/>
            <a:ext cx="2911006" cy="2650722"/>
            <a:chOff x="587382" y="2440985"/>
            <a:chExt cx="2911006" cy="2650722"/>
          </a:xfrm>
        </p:grpSpPr>
        <p:sp>
          <p:nvSpPr>
            <p:cNvPr id="7" name="Rectangle 6"/>
            <p:cNvSpPr/>
            <p:nvPr/>
          </p:nvSpPr>
          <p:spPr>
            <a:xfrm>
              <a:off x="1246239" y="4728615"/>
              <a:ext cx="243348" cy="1548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587382" y="2440985"/>
              <a:ext cx="2911006" cy="2650722"/>
              <a:chOff x="587382" y="2440985"/>
              <a:chExt cx="2911006" cy="2650722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2549089" y="4830097"/>
                <a:ext cx="94929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/>
                  <a:t>Distance (kb)</a:t>
                </a:r>
                <a:endParaRPr lang="es-ES" sz="1100" b="1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 rot="16200000">
                <a:off x="508630" y="2519737"/>
                <a:ext cx="41911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i="1" dirty="0" smtClean="0"/>
                  <a:t>r</a:t>
                </a:r>
                <a:r>
                  <a:rPr lang="en-US" sz="1100" b="1" baseline="30000" dirty="0" smtClean="0"/>
                  <a:t>2</a:t>
                </a:r>
                <a:endParaRPr lang="es-ES" sz="11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119768" y="4690948"/>
                <a:ext cx="4683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solidFill>
                      <a:srgbClr val="529028"/>
                    </a:solidFill>
                  </a:rPr>
                  <a:t>24,300</a:t>
                </a:r>
                <a:endParaRPr lang="es-ES" sz="800" b="1" dirty="0">
                  <a:solidFill>
                    <a:srgbClr val="529028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22670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38</TotalTime>
  <Words>60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</dc:creator>
  <cp:lastModifiedBy>Hernandez Vasquez, Francisco Javier</cp:lastModifiedBy>
  <cp:revision>47</cp:revision>
  <dcterms:created xsi:type="dcterms:W3CDTF">2018-07-05T20:34:08Z</dcterms:created>
  <dcterms:modified xsi:type="dcterms:W3CDTF">2020-07-02T16:01:43Z</dcterms:modified>
</cp:coreProperties>
</file>